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6535DA5-436F-4C2A-9FC6-FC30DBC5EBD6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E9FC169-7531-4CF1-BB1F-859325280E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183A254-637B-421E-9679-4E995AE5EB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2E932B1-F224-4ADB-A798-F3E147BA256E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CA4196C-E7A7-4E2A-8FAE-6828A3CC1D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A4B1553-C88F-4DB1-8FAF-9140ABD95D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2A930ED-A57D-46FB-8685-FCE961FD66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F409EDD-ADFE-4230-8631-088D370F06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1122120"/>
            <a:ext cx="7770960" cy="11059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4A4A751-C9E0-4520-8A7E-6A7FDC96BB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D44C928-A27C-4F8C-A0A7-BBD0654C74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8C8BF2D-8D63-459A-907B-17B890DC1D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3342D21-56C4-41B0-8011-5F597C8A55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1122120"/>
            <a:ext cx="77709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628200" y="6356160"/>
            <a:ext cx="20559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9/15/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6458040" y="6356160"/>
            <a:ext cx="205560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0484240F-84C8-45D4-B4EA-B3644181B815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5720" y="5440320"/>
            <a:ext cx="17582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dditional fil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0" t="23013" r="0" b="38512"/>
          <a:stretch/>
        </p:blipFill>
        <p:spPr>
          <a:xfrm>
            <a:off x="155520" y="187200"/>
            <a:ext cx="8796240" cy="47959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17360" y="5810400"/>
            <a:ext cx="8872560" cy="94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Dosing-time dependent change in the antitumor effect after CDDP 5 mg/kg i.v. every 7 days at 5:00 or 17:00 in A549 tumor bearing mice. ●: control group, □: CDDP 5:00 treated group, ■: CDDP 17:00 treated group, Arrows: CDDP administrations. Each value represents the mean ± S.E.M. of 9 or 10 mice. **: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&lt; 0.01 (Scheffe’s test). The 17:00 treated group decreased the relative tumor growth compared with the 5:00 treated group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